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6"/>
  </p:notesMasterIdLst>
  <p:sldIdLst>
    <p:sldId id="271" r:id="rId3"/>
    <p:sldId id="273" r:id="rId4"/>
    <p:sldId id="26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592" autoAdjust="0"/>
  </p:normalViewPr>
  <p:slideViewPr>
    <p:cSldViewPr snapToGrid="0">
      <p:cViewPr varScale="1">
        <p:scale>
          <a:sx n="107" d="100"/>
          <a:sy n="107" d="100"/>
        </p:scale>
        <p:origin x="16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33A0EC-E1CF-4D03-BF45-943A935C8888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E58929-2ACF-45A9-8386-7BF1CE965C5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3625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95" name="Google Shape;95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39812372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95" name="Google Shape;95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0875845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69259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4323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1489488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 Slid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2"/>
          <p:cNvSpPr txBox="1">
            <a:spLocks noGrp="1"/>
          </p:cNvSpPr>
          <p:nvPr>
            <p:ph type="ctrTitle"/>
          </p:nvPr>
        </p:nvSpPr>
        <p:spPr>
          <a:xfrm>
            <a:off x="1143000" y="1122364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7550"/>
              <a:buFont typeface="Calibri"/>
              <a:buNone/>
              <a:defRPr sz="448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12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7020"/>
              <a:buNone/>
              <a:defRPr sz="1795"/>
            </a:lvl1pPr>
            <a:lvl2pPr lvl="1" algn="ctr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850"/>
              <a:buNone/>
              <a:defRPr sz="1496"/>
            </a:lvl2pPr>
            <a:lvl3pPr lvl="2" algn="ctr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265"/>
              <a:buNone/>
              <a:defRPr sz="1346"/>
            </a:lvl3pPr>
            <a:lvl4pPr lvl="3" algn="ctr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/>
            </a:lvl4pPr>
            <a:lvl5pPr lvl="4" algn="ctr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/>
            </a:lvl5pPr>
            <a:lvl6pPr lvl="5" algn="ctr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/>
            </a:lvl6pPr>
            <a:lvl7pPr lvl="6" algn="ctr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/>
            </a:lvl7pPr>
            <a:lvl8pPr lvl="7" algn="ctr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/>
            </a:lvl8pPr>
            <a:lvl9pPr lvl="8" algn="ctr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/>
            </a:lvl9pPr>
          </a:lstStyle>
          <a:p>
            <a:endParaRPr/>
          </a:p>
        </p:txBody>
      </p:sp>
      <p:sp>
        <p:nvSpPr>
          <p:cNvPr id="14" name="Google Shape;14;p12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15" name="Google Shape;15;p12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16" name="Google Shape;16;p12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3131542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Title and Conten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3"/>
          <p:cNvSpPr txBox="1"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3"/>
          <p:cNvSpPr txBox="1">
            <a:spLocks noGrp="1"/>
          </p:cNvSpPr>
          <p:nvPr>
            <p:ph type="body" idx="1"/>
          </p:nvPr>
        </p:nvSpPr>
        <p:spPr>
          <a:xfrm>
            <a:off x="628650" y="1825626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87671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233789" lvl="1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350684" lvl="2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467579" lvl="3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584473" lvl="4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701368" lvl="5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818262" lvl="6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935157" lvl="7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1052051" lvl="8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13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21" name="Google Shape;21;p13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22" name="Google Shape;22;p13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59275609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 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4"/>
          <p:cNvSpPr txBox="1"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7550"/>
              <a:buFont typeface="Calibri"/>
              <a:buNone/>
              <a:defRPr sz="448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4"/>
          <p:cNvSpPr txBox="1">
            <a:spLocks noGrp="1"/>
          </p:cNvSpPr>
          <p:nvPr>
            <p:ph type="body" idx="1"/>
          </p:nvPr>
        </p:nvSpPr>
        <p:spPr>
          <a:xfrm>
            <a:off x="623888" y="4589465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58448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rgbClr val="888888"/>
              </a:buClr>
              <a:buSzPts val="7020"/>
              <a:buNone/>
              <a:defRPr sz="1795">
                <a:solidFill>
                  <a:srgbClr val="888888"/>
                </a:solidFill>
              </a:defRPr>
            </a:lvl1pPr>
            <a:lvl2pPr marL="233789" lvl="1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rgbClr val="888888"/>
              </a:buClr>
              <a:buSzPts val="5850"/>
              <a:buNone/>
              <a:defRPr sz="1496">
                <a:solidFill>
                  <a:srgbClr val="888888"/>
                </a:solidFill>
              </a:defRPr>
            </a:lvl2pPr>
            <a:lvl3pPr marL="350684" lvl="2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rgbClr val="888888"/>
              </a:buClr>
              <a:buSzPts val="5265"/>
              <a:buNone/>
              <a:defRPr sz="1346">
                <a:solidFill>
                  <a:srgbClr val="888888"/>
                </a:solidFill>
              </a:defRPr>
            </a:lvl3pPr>
            <a:lvl4pPr marL="467579" lvl="3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rgbClr val="888888"/>
              </a:buClr>
              <a:buSzPts val="4680"/>
              <a:buNone/>
              <a:defRPr sz="1196">
                <a:solidFill>
                  <a:srgbClr val="888888"/>
                </a:solidFill>
              </a:defRPr>
            </a:lvl4pPr>
            <a:lvl5pPr marL="584473" lvl="4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rgbClr val="888888"/>
              </a:buClr>
              <a:buSzPts val="4680"/>
              <a:buNone/>
              <a:defRPr sz="1196">
                <a:solidFill>
                  <a:srgbClr val="888888"/>
                </a:solidFill>
              </a:defRPr>
            </a:lvl5pPr>
            <a:lvl6pPr marL="701368" lvl="5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rgbClr val="888888"/>
              </a:buClr>
              <a:buSzPts val="4680"/>
              <a:buNone/>
              <a:defRPr sz="1196">
                <a:solidFill>
                  <a:srgbClr val="888888"/>
                </a:solidFill>
              </a:defRPr>
            </a:lvl6pPr>
            <a:lvl7pPr marL="818262" lvl="6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rgbClr val="888888"/>
              </a:buClr>
              <a:buSzPts val="4680"/>
              <a:buNone/>
              <a:defRPr sz="1196">
                <a:solidFill>
                  <a:srgbClr val="888888"/>
                </a:solidFill>
              </a:defRPr>
            </a:lvl7pPr>
            <a:lvl8pPr marL="935157" lvl="7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rgbClr val="888888"/>
              </a:buClr>
              <a:buSzPts val="4680"/>
              <a:buNone/>
              <a:defRPr sz="1196">
                <a:solidFill>
                  <a:srgbClr val="888888"/>
                </a:solidFill>
              </a:defRPr>
            </a:lvl8pPr>
            <a:lvl9pPr marL="1052051" lvl="8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rgbClr val="888888"/>
              </a:buClr>
              <a:buSzPts val="4680"/>
              <a:buNone/>
              <a:defRPr sz="1196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14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27" name="Google Shape;27;p14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28" name="Google Shape;28;p14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5268614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 Content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5"/>
          <p:cNvSpPr txBox="1"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5"/>
          <p:cNvSpPr txBox="1">
            <a:spLocks noGrp="1"/>
          </p:cNvSpPr>
          <p:nvPr>
            <p:ph type="body" idx="1"/>
          </p:nvPr>
        </p:nvSpPr>
        <p:spPr>
          <a:xfrm>
            <a:off x="628650" y="1825626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87671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233789" lvl="1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350684" lvl="2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467579" lvl="3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584473" lvl="4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701368" lvl="5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818262" lvl="6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935157" lvl="7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1052051" lvl="8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5"/>
          <p:cNvSpPr txBox="1">
            <a:spLocks noGrp="1"/>
          </p:cNvSpPr>
          <p:nvPr>
            <p:ph type="body" idx="2"/>
          </p:nvPr>
        </p:nvSpPr>
        <p:spPr>
          <a:xfrm>
            <a:off x="4629150" y="1825626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87671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233789" lvl="1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350684" lvl="2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467579" lvl="3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584473" lvl="4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701368" lvl="5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818262" lvl="6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935157" lvl="7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1052051" lvl="8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5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34" name="Google Shape;34;p15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35" name="Google Shape;35;p15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5047635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Comparison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6"/>
          <p:cNvSpPr txBox="1"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6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116894" lvl="0" indent="-58448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7020"/>
              <a:buNone/>
              <a:defRPr sz="1795" b="1"/>
            </a:lvl1pPr>
            <a:lvl2pPr marL="233789" lvl="1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850"/>
              <a:buNone/>
              <a:defRPr sz="1496" b="1"/>
            </a:lvl2pPr>
            <a:lvl3pPr marL="350684" lvl="2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265"/>
              <a:buNone/>
              <a:defRPr sz="1346" b="1"/>
            </a:lvl3pPr>
            <a:lvl4pPr marL="467579" lvl="3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4pPr>
            <a:lvl5pPr marL="584473" lvl="4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5pPr>
            <a:lvl6pPr marL="701368" lvl="5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6pPr>
            <a:lvl7pPr marL="818262" lvl="6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7pPr>
            <a:lvl8pPr marL="935157" lvl="7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8pPr>
            <a:lvl9pPr marL="1052051" lvl="8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9pPr>
          </a:lstStyle>
          <a:p>
            <a:endParaRPr/>
          </a:p>
        </p:txBody>
      </p:sp>
      <p:sp>
        <p:nvSpPr>
          <p:cNvPr id="39" name="Google Shape;39;p16"/>
          <p:cNvSpPr txBox="1">
            <a:spLocks noGrp="1"/>
          </p:cNvSpPr>
          <p:nvPr>
            <p:ph type="body" idx="2"/>
          </p:nvPr>
        </p:nvSpPr>
        <p:spPr>
          <a:xfrm>
            <a:off x="629842" y="2505076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87671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233789" lvl="1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350684" lvl="2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467579" lvl="3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584473" lvl="4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701368" lvl="5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818262" lvl="6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935157" lvl="7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1052051" lvl="8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6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116894" lvl="0" indent="-58448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7020"/>
              <a:buNone/>
              <a:defRPr sz="1795" b="1"/>
            </a:lvl1pPr>
            <a:lvl2pPr marL="233789" lvl="1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850"/>
              <a:buNone/>
              <a:defRPr sz="1496" b="1"/>
            </a:lvl2pPr>
            <a:lvl3pPr marL="350684" lvl="2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265"/>
              <a:buNone/>
              <a:defRPr sz="1346" b="1"/>
            </a:lvl3pPr>
            <a:lvl4pPr marL="467579" lvl="3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4pPr>
            <a:lvl5pPr marL="584473" lvl="4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5pPr>
            <a:lvl6pPr marL="701368" lvl="5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6pPr>
            <a:lvl7pPr marL="818262" lvl="6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7pPr>
            <a:lvl8pPr marL="935157" lvl="7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8pPr>
            <a:lvl9pPr marL="1052051" lvl="8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 b="1"/>
            </a:lvl9pPr>
          </a:lstStyle>
          <a:p>
            <a:endParaRPr/>
          </a:p>
        </p:txBody>
      </p:sp>
      <p:sp>
        <p:nvSpPr>
          <p:cNvPr id="41" name="Google Shape;41;p16"/>
          <p:cNvSpPr txBox="1">
            <a:spLocks noGrp="1"/>
          </p:cNvSpPr>
          <p:nvPr>
            <p:ph type="body" idx="4"/>
          </p:nvPr>
        </p:nvSpPr>
        <p:spPr>
          <a:xfrm>
            <a:off x="4629150" y="2505076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87671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233789" lvl="1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350684" lvl="2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467579" lvl="3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584473" lvl="4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701368" lvl="5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818262" lvl="6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935157" lvl="7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1052051" lvl="8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43" name="Google Shape;43;p16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44" name="Google Shape;44;p16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7449344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 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7"/>
          <p:cNvSpPr txBox="1"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7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48" name="Google Shape;48;p17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49" name="Google Shape;49;p17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1519402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8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52" name="Google Shape;52;p18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53" name="Google Shape;53;p18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0885442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Content with Caption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9"/>
          <p:cNvSpPr txBox="1">
            <a:spLocks noGrp="1"/>
          </p:cNvSpPr>
          <p:nvPr>
            <p:ph type="title"/>
          </p:nvPr>
        </p:nvSpPr>
        <p:spPr>
          <a:xfrm>
            <a:off x="629842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360"/>
              <a:buFont typeface="Calibri"/>
              <a:buNone/>
              <a:defRPr sz="239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9"/>
          <p:cNvSpPr txBox="1">
            <a:spLocks noGrp="1"/>
          </p:cNvSpPr>
          <p:nvPr>
            <p:ph type="body" idx="1"/>
          </p:nvPr>
        </p:nvSpPr>
        <p:spPr>
          <a:xfrm>
            <a:off x="3887391" y="987427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210410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9360"/>
              <a:buChar char="•"/>
              <a:defRPr sz="2393"/>
            </a:lvl1pPr>
            <a:lvl2pPr marL="233789" lvl="1" indent="-191415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8190"/>
              <a:buChar char="•"/>
              <a:defRPr sz="2094"/>
            </a:lvl2pPr>
            <a:lvl3pPr marL="350684" lvl="2" indent="-172420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7020"/>
              <a:buChar char="•"/>
              <a:defRPr sz="1795"/>
            </a:lvl3pPr>
            <a:lvl4pPr marL="467579" lvl="3" indent="-153425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850"/>
              <a:buChar char="•"/>
              <a:defRPr sz="1496"/>
            </a:lvl4pPr>
            <a:lvl5pPr marL="584473" lvl="4" indent="-153425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850"/>
              <a:buChar char="•"/>
              <a:defRPr sz="1496"/>
            </a:lvl5pPr>
            <a:lvl6pPr marL="701368" lvl="5" indent="-153425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850"/>
              <a:buChar char="•"/>
              <a:defRPr sz="1496"/>
            </a:lvl6pPr>
            <a:lvl7pPr marL="818262" lvl="6" indent="-153425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850"/>
              <a:buChar char="•"/>
              <a:defRPr sz="1496"/>
            </a:lvl7pPr>
            <a:lvl8pPr marL="935157" lvl="7" indent="-153425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850"/>
              <a:buChar char="•"/>
              <a:defRPr sz="1496"/>
            </a:lvl8pPr>
            <a:lvl9pPr marL="1052051" lvl="8" indent="-153425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5850"/>
              <a:buChar char="•"/>
              <a:defRPr sz="1496"/>
            </a:lvl9pPr>
          </a:lstStyle>
          <a:p>
            <a:endParaRPr/>
          </a:p>
        </p:txBody>
      </p:sp>
      <p:sp>
        <p:nvSpPr>
          <p:cNvPr id="57" name="Google Shape;57;p19"/>
          <p:cNvSpPr txBox="1">
            <a:spLocks noGrp="1"/>
          </p:cNvSpPr>
          <p:nvPr>
            <p:ph type="body" idx="2"/>
          </p:nvPr>
        </p:nvSpPr>
        <p:spPr>
          <a:xfrm>
            <a:off x="629842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58448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/>
            </a:lvl1pPr>
            <a:lvl2pPr marL="233789" lvl="1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095"/>
              <a:buNone/>
              <a:defRPr sz="1047"/>
            </a:lvl2pPr>
            <a:lvl3pPr marL="350684" lvl="2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3510"/>
              <a:buNone/>
              <a:defRPr sz="897"/>
            </a:lvl3pPr>
            <a:lvl4pPr marL="467579" lvl="3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4pPr>
            <a:lvl5pPr marL="584473" lvl="4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5pPr>
            <a:lvl6pPr marL="701368" lvl="5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6pPr>
            <a:lvl7pPr marL="818262" lvl="6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7pPr>
            <a:lvl8pPr marL="935157" lvl="7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8pPr>
            <a:lvl9pPr marL="1052051" lvl="8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9pPr>
          </a:lstStyle>
          <a:p>
            <a:endParaRPr/>
          </a:p>
        </p:txBody>
      </p:sp>
      <p:sp>
        <p:nvSpPr>
          <p:cNvPr id="58" name="Google Shape;58;p19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59" name="Google Shape;59;p19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60" name="Google Shape;60;p19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85947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0866588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 with Caption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0"/>
          <p:cNvSpPr txBox="1">
            <a:spLocks noGrp="1"/>
          </p:cNvSpPr>
          <p:nvPr>
            <p:ph type="title"/>
          </p:nvPr>
        </p:nvSpPr>
        <p:spPr>
          <a:xfrm>
            <a:off x="629842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360"/>
              <a:buFont typeface="Calibri"/>
              <a:buNone/>
              <a:defRPr sz="239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0"/>
          <p:cNvSpPr>
            <a:spLocks noGrp="1"/>
          </p:cNvSpPr>
          <p:nvPr>
            <p:ph type="pic" idx="2"/>
          </p:nvPr>
        </p:nvSpPr>
        <p:spPr>
          <a:xfrm>
            <a:off x="3887391" y="987427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20"/>
          <p:cNvSpPr txBox="1">
            <a:spLocks noGrp="1"/>
          </p:cNvSpPr>
          <p:nvPr>
            <p:ph type="body" idx="1"/>
          </p:nvPr>
        </p:nvSpPr>
        <p:spPr>
          <a:xfrm>
            <a:off x="629842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58448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4680"/>
              <a:buNone/>
              <a:defRPr sz="1196"/>
            </a:lvl1pPr>
            <a:lvl2pPr marL="233789" lvl="1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4095"/>
              <a:buNone/>
              <a:defRPr sz="1047"/>
            </a:lvl2pPr>
            <a:lvl3pPr marL="350684" lvl="2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3510"/>
              <a:buNone/>
              <a:defRPr sz="897"/>
            </a:lvl3pPr>
            <a:lvl4pPr marL="467579" lvl="3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4pPr>
            <a:lvl5pPr marL="584473" lvl="4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5pPr>
            <a:lvl6pPr marL="701368" lvl="5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6pPr>
            <a:lvl7pPr marL="818262" lvl="6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7pPr>
            <a:lvl8pPr marL="935157" lvl="7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8pPr>
            <a:lvl9pPr marL="1052051" lvl="8" indent="-58448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2925"/>
              <a:buNone/>
              <a:defRPr sz="748"/>
            </a:lvl9pPr>
          </a:lstStyle>
          <a:p>
            <a:endParaRPr/>
          </a:p>
        </p:txBody>
      </p:sp>
      <p:sp>
        <p:nvSpPr>
          <p:cNvPr id="65" name="Google Shape;65;p20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66" name="Google Shape;66;p20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67" name="Google Shape;67;p20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99515133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Title and Vertical 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1"/>
          <p:cNvSpPr txBox="1"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1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87671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233789" lvl="1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350684" lvl="2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467579" lvl="3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584473" lvl="4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701368" lvl="5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818262" lvl="6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935157" lvl="7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1052051" lvl="8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1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72" name="Google Shape;72;p21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73" name="Google Shape;73;p21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1243558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 Title and 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2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2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116894" lvl="0" indent="-87671" algn="l">
              <a:lnSpc>
                <a:spcPct val="90000"/>
              </a:lnSpc>
              <a:spcBef>
                <a:spcPts val="74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233789" lvl="1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350684" lvl="2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467579" lvl="3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584473" lvl="4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701368" lvl="5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818262" lvl="6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935157" lvl="7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1052051" lvl="8" indent="-87671" algn="l">
              <a:lnSpc>
                <a:spcPct val="90000"/>
              </a:lnSpc>
              <a:spcBef>
                <a:spcPts val="37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2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78" name="Google Shape;78;p22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79" name="Google Shape;79;p22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015692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04973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6482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2156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78883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5026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47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5763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AFC53A-FBE5-4597-934F-DEF7E3D39F22}" type="datetimeFigureOut">
              <a:rPr lang="en-IN" smtClean="0"/>
              <a:t>04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250BEF-350A-420C-ADEA-15AF16A44E2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6807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1"/>
          <p:cNvSpPr txBox="1"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870"/>
              <a:buFont typeface="Calibri"/>
              <a:buNone/>
              <a:defRPr sz="128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11"/>
          <p:cNvSpPr txBox="1">
            <a:spLocks noGrp="1"/>
          </p:cNvSpPr>
          <p:nvPr>
            <p:ph type="body" idx="1"/>
          </p:nvPr>
        </p:nvSpPr>
        <p:spPr>
          <a:xfrm>
            <a:off x="628650" y="1825626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748665" algn="l" rtl="0">
              <a:lnSpc>
                <a:spcPct val="90000"/>
              </a:lnSpc>
              <a:spcBef>
                <a:spcPts val="2925"/>
              </a:spcBef>
              <a:spcAft>
                <a:spcPts val="0"/>
              </a:spcAft>
              <a:buClr>
                <a:schemeClr val="dk1"/>
              </a:buClr>
              <a:buSzPts val="8190"/>
              <a:buFont typeface="Arial"/>
              <a:buChar char="•"/>
              <a:defRPr sz="81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674370" algn="l" rtl="0">
              <a:lnSpc>
                <a:spcPct val="90000"/>
              </a:lnSpc>
              <a:spcBef>
                <a:spcPts val="1463"/>
              </a:spcBef>
              <a:spcAft>
                <a:spcPts val="0"/>
              </a:spcAft>
              <a:buClr>
                <a:schemeClr val="dk1"/>
              </a:buClr>
              <a:buSzPts val="7020"/>
              <a:buFont typeface="Arial"/>
              <a:buChar char="•"/>
              <a:defRPr sz="701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600075" algn="l" rtl="0">
              <a:lnSpc>
                <a:spcPct val="90000"/>
              </a:lnSpc>
              <a:spcBef>
                <a:spcPts val="1463"/>
              </a:spcBef>
              <a:spcAft>
                <a:spcPts val="0"/>
              </a:spcAft>
              <a:buClr>
                <a:schemeClr val="dk1"/>
              </a:buClr>
              <a:buSzPts val="5850"/>
              <a:buFont typeface="Arial"/>
              <a:buChar char="•"/>
              <a:defRPr sz="58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562927" algn="l" rtl="0">
              <a:lnSpc>
                <a:spcPct val="90000"/>
              </a:lnSpc>
              <a:spcBef>
                <a:spcPts val="1463"/>
              </a:spcBef>
              <a:spcAft>
                <a:spcPts val="0"/>
              </a:spcAft>
              <a:buClr>
                <a:schemeClr val="dk1"/>
              </a:buClr>
              <a:buSzPts val="5265"/>
              <a:buFont typeface="Arial"/>
              <a:buChar char="•"/>
              <a:defRPr sz="526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562927" algn="l" rtl="0">
              <a:lnSpc>
                <a:spcPct val="90000"/>
              </a:lnSpc>
              <a:spcBef>
                <a:spcPts val="1463"/>
              </a:spcBef>
              <a:spcAft>
                <a:spcPts val="0"/>
              </a:spcAft>
              <a:buClr>
                <a:schemeClr val="dk1"/>
              </a:buClr>
              <a:buSzPts val="5265"/>
              <a:buFont typeface="Arial"/>
              <a:buChar char="•"/>
              <a:defRPr sz="526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562927" algn="l" rtl="0">
              <a:lnSpc>
                <a:spcPct val="90000"/>
              </a:lnSpc>
              <a:spcBef>
                <a:spcPts val="1463"/>
              </a:spcBef>
              <a:spcAft>
                <a:spcPts val="0"/>
              </a:spcAft>
              <a:buClr>
                <a:schemeClr val="dk1"/>
              </a:buClr>
              <a:buSzPts val="5265"/>
              <a:buFont typeface="Arial"/>
              <a:buChar char="•"/>
              <a:defRPr sz="526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562927" algn="l" rtl="0">
              <a:lnSpc>
                <a:spcPct val="90000"/>
              </a:lnSpc>
              <a:spcBef>
                <a:spcPts val="1463"/>
              </a:spcBef>
              <a:spcAft>
                <a:spcPts val="0"/>
              </a:spcAft>
              <a:buClr>
                <a:schemeClr val="dk1"/>
              </a:buClr>
              <a:buSzPts val="5265"/>
              <a:buFont typeface="Arial"/>
              <a:buChar char="•"/>
              <a:defRPr sz="526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562927" algn="l" rtl="0">
              <a:lnSpc>
                <a:spcPct val="90000"/>
              </a:lnSpc>
              <a:spcBef>
                <a:spcPts val="1463"/>
              </a:spcBef>
              <a:spcAft>
                <a:spcPts val="0"/>
              </a:spcAft>
              <a:buClr>
                <a:schemeClr val="dk1"/>
              </a:buClr>
              <a:buSzPts val="5265"/>
              <a:buFont typeface="Arial"/>
              <a:buChar char="•"/>
              <a:defRPr sz="526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562927" algn="l" rtl="0">
              <a:lnSpc>
                <a:spcPct val="90000"/>
              </a:lnSpc>
              <a:spcBef>
                <a:spcPts val="1463"/>
              </a:spcBef>
              <a:spcAft>
                <a:spcPts val="0"/>
              </a:spcAft>
              <a:buClr>
                <a:schemeClr val="dk1"/>
              </a:buClr>
              <a:buSzPts val="5265"/>
              <a:buFont typeface="Arial"/>
              <a:buChar char="•"/>
              <a:defRPr sz="526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1"/>
          <p:cNvSpPr txBox="1">
            <a:spLocks noGrp="1"/>
          </p:cNvSpPr>
          <p:nvPr>
            <p:ph type="dt" idx="10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9" name="Google Shape;9;p11"/>
          <p:cNvSpPr txBox="1">
            <a:spLocks noGrp="1"/>
          </p:cNvSpPr>
          <p:nvPr>
            <p:ph type="ftr" idx="11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kumimoji="0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sp>
        <p:nvSpPr>
          <p:cNvPr id="10" name="Google Shape;10;p11"/>
          <p:cNvSpPr txBox="1">
            <a:spLocks noGrp="1"/>
          </p:cNvSpPr>
          <p:nvPr>
            <p:ph type="sldNum" idx="12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defRPr sz="89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509"/>
              <a:buFont typeface="Arial"/>
              <a:buNone/>
              <a:tabLst/>
              <a:defRPr/>
            </a:pPr>
            <a:fld id="{00000000-1234-1234-1234-123412341234}" type="slidenum">
              <a:rPr kumimoji="0" lang="en-US" sz="897" b="0" i="0" u="none" strike="noStrike" kern="0" cap="none" spc="0" normalizeH="0" baseline="0" noProof="0" smtClean="0">
                <a:ln>
                  <a:noFill/>
                </a:ln>
                <a:solidFill>
                  <a:srgbClr val="888888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509"/>
                <a:buFont typeface="Arial"/>
                <a:buNone/>
                <a:tabLst/>
                <a:defRPr/>
              </a:pPr>
              <a:t>‹#›</a:t>
            </a:fld>
            <a:endParaRPr kumimoji="0" lang="en-US" sz="897" b="0" i="0" u="none" strike="noStrike" kern="0" cap="none" spc="0" normalizeH="0" baseline="0" noProof="0">
              <a:ln>
                <a:noFill/>
              </a:ln>
              <a:solidFill>
                <a:srgbClr val="888888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218004253"/>
      </p:ext>
    </p:extLst>
  </p:cSld>
  <p:clrMap bg1="lt1" tx1="dk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358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5" name="Rectangle 74">
            <a:extLst>
              <a:ext uri="{FF2B5EF4-FFF2-40B4-BE49-F238E27FC236}">
                <a16:creationId xmlns:a16="http://schemas.microsoft.com/office/drawing/2014/main" id="{EB270761-CC40-4F3F-A916-7E3BC3989348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857250"/>
            <a:ext cx="9143771" cy="51435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358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  <a:sym typeface="Arial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0DB7897-C5BC-4B5C-BBB6-B6EC515405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084197" y="3314936"/>
            <a:ext cx="7414344" cy="942902"/>
          </a:xfrm>
        </p:spPr>
        <p:txBody>
          <a:bodyPr>
            <a:noAutofit/>
          </a:bodyPr>
          <a:lstStyle/>
          <a:p>
            <a:r>
              <a:rPr lang="en-US" sz="2800" dirty="0">
                <a:latin typeface="Segoe UI" panose="020B0502040204020203" pitchFamily="34" charset="0"/>
              </a:rPr>
              <a:t>Microbiome analysis of </a:t>
            </a:r>
            <a:r>
              <a:rPr lang="en-US" sz="2800" dirty="0" err="1">
                <a:latin typeface="Segoe UI" panose="020B0502040204020203" pitchFamily="34" charset="0"/>
              </a:rPr>
              <a:t>Aggregatibacter</a:t>
            </a:r>
            <a:r>
              <a:rPr lang="en-US" sz="2800" dirty="0">
                <a:latin typeface="Segoe UI" panose="020B0502040204020203" pitchFamily="34" charset="0"/>
              </a:rPr>
              <a:t> </a:t>
            </a:r>
            <a:r>
              <a:rPr lang="en-US" sz="2800" dirty="0" err="1">
                <a:latin typeface="Segoe UI" panose="020B0502040204020203" pitchFamily="34" charset="0"/>
              </a:rPr>
              <a:t>actinomycetemcomitans</a:t>
            </a:r>
            <a:r>
              <a:rPr lang="en-US" sz="2800" dirty="0">
                <a:latin typeface="Segoe UI" panose="020B0502040204020203" pitchFamily="34" charset="0"/>
              </a:rPr>
              <a:t> JP2 clone-associated aggressive periodontitis in a Moroccan population</a:t>
            </a:r>
            <a:r>
              <a:rPr lang="en-US" sz="3000" dirty="0">
                <a:latin typeface="Segoe UI" panose="020B0502040204020203" pitchFamily="34" charset="0"/>
              </a:rPr>
              <a:t/>
            </a:r>
            <a:br>
              <a:rPr lang="en-US" sz="3000" dirty="0">
                <a:latin typeface="Segoe UI" panose="020B0502040204020203" pitchFamily="34" charset="0"/>
              </a:rPr>
            </a:br>
            <a:r>
              <a:rPr lang="en-US" sz="3000" dirty="0">
                <a:latin typeface="Segoe UI" panose="020B0502040204020203" pitchFamily="34" charset="0"/>
              </a:rPr>
              <a:t/>
            </a:r>
            <a:br>
              <a:rPr lang="en-US" sz="3000" dirty="0">
                <a:latin typeface="Segoe UI" panose="020B0502040204020203" pitchFamily="34" charset="0"/>
              </a:rPr>
            </a:br>
            <a:r>
              <a:rPr lang="en-US" sz="3000" dirty="0">
                <a:solidFill>
                  <a:srgbClr val="FF0000"/>
                </a:solidFill>
                <a:latin typeface="Segoe UI" panose="020B0502040204020203" pitchFamily="34" charset="0"/>
              </a:rPr>
              <a:t>Supplementary Figures</a:t>
            </a:r>
            <a:endParaRPr lang="en-US" sz="3000" dirty="0">
              <a:solidFill>
                <a:srgbClr val="FF0000"/>
              </a:solidFill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EF5FE77B-EA4C-4573-8509-E577DCA8AF45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1525905"/>
            <a:ext cx="541782" cy="3803333"/>
          </a:xfrm>
          <a:prstGeom prst="rect">
            <a:avLst/>
          </a:prstGeom>
          <a:solidFill>
            <a:srgbClr val="4C525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endParaRPr kumimoji="0" lang="en-US" sz="358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41330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3"/>
          <p:cNvSpPr txBox="1"/>
          <p:nvPr/>
        </p:nvSpPr>
        <p:spPr>
          <a:xfrm>
            <a:off x="1140674" y="5102046"/>
            <a:ext cx="7073235" cy="8738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3376" tIns="11685" rIns="23376" bIns="11685" anchor="t" anchorCtr="0">
            <a:spAutoFit/>
          </a:bodyPr>
          <a:lstStyle/>
          <a:p>
            <a:pPr>
              <a:buClr>
                <a:srgbClr val="000000"/>
              </a:buClr>
              <a:buSzPts val="7500"/>
            </a:pPr>
            <a:r>
              <a:rPr lang="en-US" sz="1125" b="1" dirty="0">
                <a:solidFill>
                  <a:schemeClr val="dk1"/>
                </a:solidFill>
                <a:ea typeface="Calibri"/>
                <a:cs typeface="Times New Roman" panose="02020603050405020304" pitchFamily="18" charset="0"/>
                <a:sym typeface="Calibri"/>
              </a:rPr>
              <a:t>Supplementary Figure 1. </a:t>
            </a:r>
            <a:r>
              <a:rPr lang="en-US" sz="1100" b="1" dirty="0"/>
              <a:t>Top differentially abundant </a:t>
            </a:r>
            <a:r>
              <a:rPr lang="en-US" sz="1100" b="1" dirty="0" smtClean="0"/>
              <a:t>genera </a:t>
            </a:r>
            <a:r>
              <a:rPr lang="en-US" sz="1100" b="1" dirty="0"/>
              <a:t>between AP and health.</a:t>
            </a:r>
            <a:r>
              <a:rPr lang="en-US" sz="1100" dirty="0"/>
              <a:t> Centered log ratio (CLR) transformed data were analyzed with MaAsLin2 to identify differentially abundant </a:t>
            </a:r>
            <a:r>
              <a:rPr lang="en-US" sz="1100" dirty="0" smtClean="0"/>
              <a:t>genera </a:t>
            </a:r>
            <a:r>
              <a:rPr lang="en-US" sz="1100" dirty="0"/>
              <a:t>between the healthy controls and shallow pockets from the AP cases (</a:t>
            </a:r>
            <a:r>
              <a:rPr lang="en-US" sz="1100" b="1" dirty="0"/>
              <a:t>A</a:t>
            </a:r>
            <a:r>
              <a:rPr lang="en-US" sz="1100" dirty="0"/>
              <a:t>) and between the healthy controls and deep pockets from the AP cases (</a:t>
            </a:r>
            <a:r>
              <a:rPr lang="en-US" sz="1100" b="1" dirty="0"/>
              <a:t>B</a:t>
            </a:r>
            <a:r>
              <a:rPr lang="en-US" sz="1100" dirty="0"/>
              <a:t>). Differences with FDR≤0.1 were considered significant. The top </a:t>
            </a:r>
            <a:r>
              <a:rPr lang="en-US" sz="1100" dirty="0" smtClean="0"/>
              <a:t>20 genera </a:t>
            </a:r>
            <a:r>
              <a:rPr lang="en-US" sz="1100" dirty="0"/>
              <a:t>based on magnitude of association (coefficient) are shown in </a:t>
            </a:r>
            <a:r>
              <a:rPr lang="en-US" sz="1100" b="1" dirty="0"/>
              <a:t>A</a:t>
            </a:r>
            <a:r>
              <a:rPr lang="en-US" sz="1100" dirty="0"/>
              <a:t> and </a:t>
            </a:r>
            <a:r>
              <a:rPr lang="en-US" sz="1100" b="1" dirty="0"/>
              <a:t>B</a:t>
            </a:r>
            <a:r>
              <a:rPr lang="en-US" sz="1100" dirty="0"/>
              <a:t>. </a:t>
            </a:r>
            <a:endParaRPr sz="1100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0674" y="1313120"/>
            <a:ext cx="6586902" cy="34096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55787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3"/>
          <p:cNvSpPr txBox="1"/>
          <p:nvPr/>
        </p:nvSpPr>
        <p:spPr>
          <a:xfrm>
            <a:off x="1068956" y="4528304"/>
            <a:ext cx="7073235" cy="7007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3376" tIns="11685" rIns="23376" bIns="11685" anchor="t" anchorCtr="0">
            <a:spAutoFit/>
          </a:bodyPr>
          <a:lstStyle/>
          <a:p>
            <a:pPr>
              <a:buClr>
                <a:srgbClr val="000000"/>
              </a:buClr>
              <a:buSzPts val="7500"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upplementary Figure </a:t>
            </a:r>
            <a:r>
              <a:rPr lang="en-US" sz="1100" b="1" dirty="0" smtClean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2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op differentially abundan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xa between shallow and deep pockets in AP.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ntered log ratio (CLR) transformed data were analyzed with MaAsLin2 to identify differentially abundan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enera (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and species (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between shallow and deep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ocket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the AP cases. FDR of 0.25 and nominal P value of 0.01 were used as cutoff for defining significant differences for genera and species, respectively. </a:t>
            </a:r>
            <a:endParaRPr lang="en-US" sz="1100" dirty="0">
              <a:solidFill>
                <a:schemeClr val="dk1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424" y="1915339"/>
            <a:ext cx="7736541" cy="2363627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572871" y="1915339"/>
            <a:ext cx="1129553" cy="3168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803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83</TotalTime>
  <Words>175</Words>
  <Application>Microsoft Office PowerPoint</Application>
  <PresentationFormat>On-screen Show (4:3)</PresentationFormat>
  <Paragraphs>3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Segoe UI</vt:lpstr>
      <vt:lpstr>Times New Roman</vt:lpstr>
      <vt:lpstr>Office Theme</vt:lpstr>
      <vt:lpstr>1_Office Theme</vt:lpstr>
      <vt:lpstr>Microbiome analysis of Aggregatibacter actinomycetemcomitans JP2 clone-associated aggressive periodontitis in a Moroccan population  Supplementary Figures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ay Jain</dc:creator>
  <cp:lastModifiedBy>Nezar Al-Hebshi</cp:lastModifiedBy>
  <cp:revision>61</cp:revision>
  <dcterms:created xsi:type="dcterms:W3CDTF">2022-02-11T17:41:47Z</dcterms:created>
  <dcterms:modified xsi:type="dcterms:W3CDTF">2023-04-04T18:24:52Z</dcterms:modified>
</cp:coreProperties>
</file>